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2" r:id="rId2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40" autoAdjust="0"/>
    <p:restoredTop sz="94633"/>
  </p:normalViewPr>
  <p:slideViewPr>
    <p:cSldViewPr snapToGrid="0" snapToObjects="1">
      <p:cViewPr varScale="1">
        <p:scale>
          <a:sx n="80" d="100"/>
          <a:sy n="80" d="100"/>
        </p:scale>
        <p:origin x="29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3rd%20manuscript\Data%20for%203rd%20paper\rtpcrd3con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Gene%20expression%20analysis\Rtpcr%20data\Day3-3replications_other%20part%20of%20sheath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Gene%20expression%20analysis\Rtpcr%20data\Day3-3replications_other%20part%20of%20sheath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Gene%20expression%20analysis\Rtpcr%20data\Day3-3replications_other%20part%20of%20sheath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3rd%20manuscript\Data%20for%203rd%20paper\200328OsNHX4CCC1homolog_realtimePCR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3rd%20manuscript\Data%20for%203rd%20paper\rtpcrd3cont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3rd%20manuscript\Data%20for%203rd%20paper\rtpcrd3cont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3rd%20manuscript\Data%20for%203rd%20paper\rtpcrd3cont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Gene%20expression%20analysis\Rtpcr%20data\Day3-3replications_other%20part%20of%20sheath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Gene%20expression%20analysis\Rtpcr%20data\Day3-3replications_other%20part%20of%20sheath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Gene%20expression%20analysis\Rtpcr%20data\Day3-3replications_other%20part%20of%20sheath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Gene%20expression%20analysis\Rtpcr%20data\Day3-3replications_other%20part%20of%20sheath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Gene%20expression%20analysis\Rtpcr%20data\Day3-3replications_other%20part%20of%20sheath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2;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OsHKT2;4'!$L$29,'OsHKT2;4'!$L$32)</c:f>
                <c:numCache>
                  <c:formatCode>General</c:formatCode>
                  <c:ptCount val="2"/>
                  <c:pt idx="0">
                    <c:v>5.1017153039017877</c:v>
                  </c:pt>
                  <c:pt idx="1">
                    <c:v>9.6502288448460707</c:v>
                  </c:pt>
                </c:numCache>
              </c:numRef>
            </c:plus>
            <c:minus>
              <c:numRef>
                <c:f>('OsHKT2;4'!$L$29,'OsHKT2;4'!$L$32)</c:f>
                <c:numCache>
                  <c:formatCode>General</c:formatCode>
                  <c:ptCount val="2"/>
                  <c:pt idx="0">
                    <c:v>5.1017153039017877</c:v>
                  </c:pt>
                  <c:pt idx="1">
                    <c:v>9.65022884484607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sHKT2;4'!$N$2:$N$3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('OsHKT2;4'!$K$29,'OsHKT2;4'!$K$32)</c:f>
              <c:numCache>
                <c:formatCode>General</c:formatCode>
                <c:ptCount val="2"/>
                <c:pt idx="0">
                  <c:v>10.233048000547335</c:v>
                </c:pt>
                <c:pt idx="1">
                  <c:v>18.9596624449709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CFE-8A48-B1A1-BC78B2599575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OsHKT2;4'!$L$41,'OsHKT2;4'!$L$44)</c:f>
                <c:numCache>
                  <c:formatCode>General</c:formatCode>
                  <c:ptCount val="2"/>
                  <c:pt idx="0">
                    <c:v>9.7137234982131169</c:v>
                  </c:pt>
                  <c:pt idx="1">
                    <c:v>13.947337377595707</c:v>
                  </c:pt>
                </c:numCache>
              </c:numRef>
            </c:plus>
            <c:minus>
              <c:numRef>
                <c:f>('OsHKT2;4'!$L$41,'OsHKT2;4'!$L$44)</c:f>
                <c:numCache>
                  <c:formatCode>General</c:formatCode>
                  <c:ptCount val="2"/>
                  <c:pt idx="0">
                    <c:v>9.7137234982131169</c:v>
                  </c:pt>
                  <c:pt idx="1">
                    <c:v>13.9473373775957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sHKT2;4'!$N$2:$N$3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('OsHKT2;4'!$K$41,'OsHKT2;4'!$K$44)</c:f>
              <c:numCache>
                <c:formatCode>General</c:formatCode>
                <c:ptCount val="2"/>
                <c:pt idx="0">
                  <c:v>20.066499309180731</c:v>
                </c:pt>
                <c:pt idx="1">
                  <c:v>23.057424015382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CFE-8A48-B1A1-BC78B25995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74606303"/>
        <c:axId val="774607935"/>
      </c:barChart>
      <c:catAx>
        <c:axId val="77460630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74607935"/>
        <c:crosses val="autoZero"/>
        <c:auto val="1"/>
        <c:lblAlgn val="ctr"/>
        <c:lblOffset val="100"/>
        <c:noMultiLvlLbl val="0"/>
      </c:catAx>
      <c:valAx>
        <c:axId val="774607935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7460630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NHX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59:$F$59</c:f>
                <c:numCache>
                  <c:formatCode>General</c:formatCode>
                  <c:ptCount val="4"/>
                  <c:pt idx="0">
                    <c:v>0.10993835141164846</c:v>
                  </c:pt>
                  <c:pt idx="1">
                    <c:v>0.54130747064656126</c:v>
                  </c:pt>
                  <c:pt idx="2">
                    <c:v>0.10736930039199594</c:v>
                  </c:pt>
                  <c:pt idx="3">
                    <c:v>0.20647625636969608</c:v>
                  </c:pt>
                </c:numCache>
              </c:numRef>
            </c:plus>
            <c:minus>
              <c:numRef>
                <c:f>Sheet1!$C$59:$F$59</c:f>
                <c:numCache>
                  <c:formatCode>General</c:formatCode>
                  <c:ptCount val="4"/>
                  <c:pt idx="0">
                    <c:v>0.10993835141164846</c:v>
                  </c:pt>
                  <c:pt idx="1">
                    <c:v>0.54130747064656126</c:v>
                  </c:pt>
                  <c:pt idx="2">
                    <c:v>0.10736930039199594</c:v>
                  </c:pt>
                  <c:pt idx="3">
                    <c:v>0.206476256369696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28:$Q$28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Sheet1!$D$34:$E$34</c:f>
              <c:numCache>
                <c:formatCode>General</c:formatCode>
                <c:ptCount val="2"/>
                <c:pt idx="0">
                  <c:v>4.0983333333333336</c:v>
                </c:pt>
                <c:pt idx="1">
                  <c:v>4.811666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2B8-F849-AA14-3455B23475F2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59:$R$59</c:f>
                <c:numCache>
                  <c:formatCode>General</c:formatCode>
                  <c:ptCount val="4"/>
                  <c:pt idx="0">
                    <c:v>0.17904561802326616</c:v>
                  </c:pt>
                  <c:pt idx="1">
                    <c:v>9.7408646661600054E-2</c:v>
                  </c:pt>
                  <c:pt idx="2">
                    <c:v>0.20720065422462142</c:v>
                  </c:pt>
                  <c:pt idx="3">
                    <c:v>0.2592517009480263</c:v>
                  </c:pt>
                </c:numCache>
              </c:numRef>
            </c:plus>
            <c:minus>
              <c:numRef>
                <c:f>Sheet1!$O$59:$R$59</c:f>
                <c:numCache>
                  <c:formatCode>General</c:formatCode>
                  <c:ptCount val="4"/>
                  <c:pt idx="0">
                    <c:v>0.17904561802326616</c:v>
                  </c:pt>
                  <c:pt idx="1">
                    <c:v>9.7408646661600054E-2</c:v>
                  </c:pt>
                  <c:pt idx="2">
                    <c:v>0.20720065422462142</c:v>
                  </c:pt>
                  <c:pt idx="3">
                    <c:v>0.25925170094802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28:$Q$28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Sheet1!$P$34:$Q$34</c:f>
              <c:numCache>
                <c:formatCode>General</c:formatCode>
                <c:ptCount val="2"/>
                <c:pt idx="0">
                  <c:v>3.5483333333333333</c:v>
                </c:pt>
                <c:pt idx="1">
                  <c:v>4.191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2B8-F849-AA14-3455B23475F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50707584"/>
        <c:axId val="1050929104"/>
      </c:barChart>
      <c:catAx>
        <c:axId val="1050707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50929104"/>
        <c:crosses val="autoZero"/>
        <c:auto val="1"/>
        <c:lblAlgn val="ctr"/>
        <c:lblOffset val="100"/>
        <c:noMultiLvlLbl val="0"/>
      </c:catAx>
      <c:valAx>
        <c:axId val="105092910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507075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NHX5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60:$F$60</c:f>
                <c:numCache>
                  <c:formatCode>General</c:formatCode>
                  <c:ptCount val="4"/>
                  <c:pt idx="0">
                    <c:v>7.7067596591852125E-2</c:v>
                  </c:pt>
                  <c:pt idx="1">
                    <c:v>0.30712501978474033</c:v>
                  </c:pt>
                  <c:pt idx="2">
                    <c:v>5.6453520705089785E-2</c:v>
                  </c:pt>
                  <c:pt idx="3">
                    <c:v>0.21750121327886371</c:v>
                  </c:pt>
                </c:numCache>
              </c:numRef>
            </c:plus>
            <c:minus>
              <c:numRef>
                <c:f>Sheet1!$C$60:$F$60</c:f>
                <c:numCache>
                  <c:formatCode>General</c:formatCode>
                  <c:ptCount val="4"/>
                  <c:pt idx="0">
                    <c:v>7.7067596591852125E-2</c:v>
                  </c:pt>
                  <c:pt idx="1">
                    <c:v>0.30712501978474033</c:v>
                  </c:pt>
                  <c:pt idx="2">
                    <c:v>5.6453520705089785E-2</c:v>
                  </c:pt>
                  <c:pt idx="3">
                    <c:v>0.217501213278863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28:$Q$28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Sheet1!$D$35:$E$35</c:f>
              <c:numCache>
                <c:formatCode>General</c:formatCode>
                <c:ptCount val="2"/>
                <c:pt idx="0">
                  <c:v>2.3523333333333336</c:v>
                </c:pt>
                <c:pt idx="1">
                  <c:v>3.023999999999999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B68-F84C-BFB0-0EA36AC62494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60:$R$60</c:f>
                <c:numCache>
                  <c:formatCode>General</c:formatCode>
                  <c:ptCount val="4"/>
                  <c:pt idx="0">
                    <c:v>0.10681188032132831</c:v>
                  </c:pt>
                  <c:pt idx="1">
                    <c:v>0.12497599769555752</c:v>
                  </c:pt>
                  <c:pt idx="2">
                    <c:v>0.11006412272448773</c:v>
                  </c:pt>
                  <c:pt idx="3">
                    <c:v>0.10050262572578778</c:v>
                  </c:pt>
                </c:numCache>
              </c:numRef>
            </c:plus>
            <c:minus>
              <c:numRef>
                <c:f>Sheet1!$O$60:$R$60</c:f>
                <c:numCache>
                  <c:formatCode>General</c:formatCode>
                  <c:ptCount val="4"/>
                  <c:pt idx="0">
                    <c:v>0.10681188032132831</c:v>
                  </c:pt>
                  <c:pt idx="1">
                    <c:v>0.12497599769555752</c:v>
                  </c:pt>
                  <c:pt idx="2">
                    <c:v>0.11006412272448773</c:v>
                  </c:pt>
                  <c:pt idx="3">
                    <c:v>0.100502625725787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28:$Q$28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Sheet1!$P$35:$Q$35</c:f>
              <c:numCache>
                <c:formatCode>General</c:formatCode>
                <c:ptCount val="2"/>
                <c:pt idx="0">
                  <c:v>2.7749999999999999</c:v>
                </c:pt>
                <c:pt idx="1">
                  <c:v>2.927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B68-F84C-BFB0-0EA36AC6249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6418032"/>
        <c:axId val="1076420352"/>
      </c:barChart>
      <c:catAx>
        <c:axId val="1076418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6420352"/>
        <c:crosses val="autoZero"/>
        <c:auto val="1"/>
        <c:lblAlgn val="ctr"/>
        <c:lblOffset val="100"/>
        <c:noMultiLvlLbl val="0"/>
      </c:catAx>
      <c:valAx>
        <c:axId val="1076420352"/>
        <c:scaling>
          <c:orientation val="minMax"/>
        </c:scaling>
        <c:delete val="0"/>
        <c:axPos val="l"/>
        <c:numFmt formatCode="General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641803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SOS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61:$F$61</c:f>
                <c:numCache>
                  <c:formatCode>General</c:formatCode>
                  <c:ptCount val="4"/>
                  <c:pt idx="0">
                    <c:v>5.4073602103470508E-2</c:v>
                  </c:pt>
                  <c:pt idx="1">
                    <c:v>0.1449245014175006</c:v>
                  </c:pt>
                  <c:pt idx="2">
                    <c:v>6.0871449246205168E-2</c:v>
                  </c:pt>
                  <c:pt idx="3">
                    <c:v>0.17545369759568963</c:v>
                  </c:pt>
                </c:numCache>
              </c:numRef>
            </c:plus>
            <c:minus>
              <c:numRef>
                <c:f>Sheet1!$C$61:$F$61</c:f>
                <c:numCache>
                  <c:formatCode>General</c:formatCode>
                  <c:ptCount val="4"/>
                  <c:pt idx="0">
                    <c:v>5.4073602103470508E-2</c:v>
                  </c:pt>
                  <c:pt idx="1">
                    <c:v>0.1449245014175006</c:v>
                  </c:pt>
                  <c:pt idx="2">
                    <c:v>6.0871449246205168E-2</c:v>
                  </c:pt>
                  <c:pt idx="3">
                    <c:v>0.175453697595689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28:$Q$28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Sheet1!$D$36:$E$36</c:f>
              <c:numCache>
                <c:formatCode>General</c:formatCode>
                <c:ptCount val="2"/>
                <c:pt idx="0">
                  <c:v>2.3246666666666669</c:v>
                </c:pt>
                <c:pt idx="1">
                  <c:v>1.852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6B7-E040-9681-CC4EF8F15B52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61:$R$61</c:f>
                <c:numCache>
                  <c:formatCode>General</c:formatCode>
                  <c:ptCount val="4"/>
                  <c:pt idx="0">
                    <c:v>9.2672062193042318E-2</c:v>
                  </c:pt>
                  <c:pt idx="1">
                    <c:v>0.16216486809554334</c:v>
                  </c:pt>
                  <c:pt idx="2">
                    <c:v>0.13584836317666027</c:v>
                  </c:pt>
                  <c:pt idx="3">
                    <c:v>4.2525809156845465E-2</c:v>
                  </c:pt>
                </c:numCache>
              </c:numRef>
            </c:plus>
            <c:minus>
              <c:numRef>
                <c:f>Sheet1!$O$61:$R$61</c:f>
                <c:numCache>
                  <c:formatCode>General</c:formatCode>
                  <c:ptCount val="4"/>
                  <c:pt idx="0">
                    <c:v>9.2672062193042318E-2</c:v>
                  </c:pt>
                  <c:pt idx="1">
                    <c:v>0.16216486809554334</c:v>
                  </c:pt>
                  <c:pt idx="2">
                    <c:v>0.13584836317666027</c:v>
                  </c:pt>
                  <c:pt idx="3">
                    <c:v>4.252580915684546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28:$Q$28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Sheet1!$P$36:$Q$36</c:f>
              <c:numCache>
                <c:formatCode>General</c:formatCode>
                <c:ptCount val="2"/>
                <c:pt idx="0">
                  <c:v>2.180333333333333</c:v>
                </c:pt>
                <c:pt idx="1">
                  <c:v>2.10933333333333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6B7-E040-9681-CC4EF8F15B5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6434480"/>
        <c:axId val="1076436800"/>
      </c:barChart>
      <c:catAx>
        <c:axId val="10764344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6436800"/>
        <c:crosses val="autoZero"/>
        <c:auto val="1"/>
        <c:lblAlgn val="ctr"/>
        <c:lblOffset val="100"/>
        <c:noMultiLvlLbl val="0"/>
      </c:catAx>
      <c:valAx>
        <c:axId val="1076436800"/>
        <c:scaling>
          <c:orientation val="minMax"/>
        </c:scaling>
        <c:delete val="0"/>
        <c:axPos val="l"/>
        <c:numFmt formatCode="General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643448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NHX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L$38,Sheet1!$L$42)</c:f>
                <c:numCache>
                  <c:formatCode>General</c:formatCode>
                  <c:ptCount val="2"/>
                  <c:pt idx="0">
                    <c:v>1.2981133902000732</c:v>
                  </c:pt>
                  <c:pt idx="1">
                    <c:v>0</c:v>
                  </c:pt>
                </c:numCache>
              </c:numRef>
            </c:plus>
            <c:minus>
              <c:numRef>
                <c:f>(Sheet1!$L$38,Sheet1!$L$42)</c:f>
                <c:numCache>
                  <c:formatCode>General</c:formatCode>
                  <c:ptCount val="2"/>
                  <c:pt idx="0">
                    <c:v>1.2981133902000732</c:v>
                  </c:pt>
                  <c:pt idx="1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30:$M$31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(Sheet1!$K$38,Sheet1!$K$42)</c:f>
              <c:numCache>
                <c:formatCode>General</c:formatCode>
                <c:ptCount val="2"/>
                <c:pt idx="0">
                  <c:v>1.569797105831588</c:v>
                </c:pt>
                <c:pt idx="1">
                  <c:v>0.757858283255197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9E8-BF4B-89D8-1B0070077089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Sheet1!$L$54,Sheet1!$L$58)</c:f>
                <c:numCache>
                  <c:formatCode>General</c:formatCode>
                  <c:ptCount val="2"/>
                  <c:pt idx="0">
                    <c:v>6.3343998198844842E-3</c:v>
                  </c:pt>
                  <c:pt idx="1">
                    <c:v>3.716054167687792E-2</c:v>
                  </c:pt>
                </c:numCache>
              </c:numRef>
            </c:plus>
            <c:minus>
              <c:numRef>
                <c:f>(Sheet1!$L$54,Sheet1!$L$58)</c:f>
                <c:numCache>
                  <c:formatCode>General</c:formatCode>
                  <c:ptCount val="2"/>
                  <c:pt idx="0">
                    <c:v>6.3343998198844842E-3</c:v>
                  </c:pt>
                  <c:pt idx="1">
                    <c:v>3.71605416768779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M$30:$M$31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(Sheet1!$K$54,Sheet1!$K$58)</c:f>
              <c:numCache>
                <c:formatCode>General</c:formatCode>
                <c:ptCount val="2"/>
                <c:pt idx="0">
                  <c:v>0.45695963112530114</c:v>
                </c:pt>
                <c:pt idx="1">
                  <c:v>0.3263325876532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9E8-BF4B-89D8-1B007007708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66389711"/>
        <c:axId val="766391343"/>
      </c:barChart>
      <c:catAx>
        <c:axId val="7663897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66391343"/>
        <c:crosses val="autoZero"/>
        <c:auto val="1"/>
        <c:lblAlgn val="ctr"/>
        <c:lblOffset val="100"/>
        <c:noMultiLvlLbl val="0"/>
      </c:catAx>
      <c:valAx>
        <c:axId val="766391343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6638971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2;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OsHKT2;3'!$L$29,'OsHKT2;3'!$L$32)</c:f>
                <c:numCache>
                  <c:formatCode>General</c:formatCode>
                  <c:ptCount val="2"/>
                  <c:pt idx="0">
                    <c:v>2.0562152677272927</c:v>
                  </c:pt>
                  <c:pt idx="1">
                    <c:v>1.306127222289464</c:v>
                  </c:pt>
                </c:numCache>
              </c:numRef>
            </c:plus>
            <c:minus>
              <c:numRef>
                <c:f>('OsHKT2;3'!$L$29,'OsHKT2;3'!$L$32)</c:f>
                <c:numCache>
                  <c:formatCode>General</c:formatCode>
                  <c:ptCount val="2"/>
                  <c:pt idx="0">
                    <c:v>2.0562152677272927</c:v>
                  </c:pt>
                  <c:pt idx="1">
                    <c:v>1.3061272222894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sHKT2;3'!$N$2:$N$3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('OsHKT2;3'!$K$29,'OsHKT2;3'!$K$32)</c:f>
              <c:numCache>
                <c:formatCode>General</c:formatCode>
                <c:ptCount val="2"/>
                <c:pt idx="0">
                  <c:v>2.8752788832037748</c:v>
                </c:pt>
                <c:pt idx="1">
                  <c:v>2.75784914312872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F7-884D-8321-1852825E97CF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OsHKT2;3'!$L$41,'OsHKT2;3'!$L$44)</c:f>
                <c:numCache>
                  <c:formatCode>General</c:formatCode>
                  <c:ptCount val="2"/>
                  <c:pt idx="0">
                    <c:v>0.78102314115409011</c:v>
                  </c:pt>
                  <c:pt idx="1">
                    <c:v>1.561926414696206</c:v>
                  </c:pt>
                </c:numCache>
              </c:numRef>
            </c:plus>
            <c:minus>
              <c:numRef>
                <c:f>('OsHKT2;3'!$L$41,'OsHKT2;3'!$L$44)</c:f>
                <c:numCache>
                  <c:formatCode>General</c:formatCode>
                  <c:ptCount val="2"/>
                  <c:pt idx="0">
                    <c:v>0.78102314115409011</c:v>
                  </c:pt>
                  <c:pt idx="1">
                    <c:v>1.56192641469620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sHKT2;3'!$N$2:$N$3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('OsHKT2;3'!$K$41,'OsHKT2;3'!$K$44)</c:f>
              <c:numCache>
                <c:formatCode>General</c:formatCode>
                <c:ptCount val="2"/>
                <c:pt idx="0">
                  <c:v>1.4716697657684661</c:v>
                </c:pt>
                <c:pt idx="1">
                  <c:v>2.46413213157575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BF7-884D-8321-1852825E97C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73998015"/>
        <c:axId val="766608575"/>
      </c:barChart>
      <c:catAx>
        <c:axId val="77399801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66608575"/>
        <c:crosses val="autoZero"/>
        <c:auto val="1"/>
        <c:lblAlgn val="ctr"/>
        <c:lblOffset val="100"/>
        <c:noMultiLvlLbl val="0"/>
      </c:catAx>
      <c:valAx>
        <c:axId val="766608575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7399801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2;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OsHKT2;1'!$L$29,'OsHKT2;1'!$L$32)</c:f>
                <c:numCache>
                  <c:formatCode>General</c:formatCode>
                  <c:ptCount val="2"/>
                  <c:pt idx="0">
                    <c:v>1.666060172402404</c:v>
                  </c:pt>
                  <c:pt idx="1">
                    <c:v>63.835695272867746</c:v>
                  </c:pt>
                </c:numCache>
              </c:numRef>
            </c:plus>
            <c:minus>
              <c:numRef>
                <c:f>('OsHKT2;1'!$L$29,'OsHKT2;1'!$L$32)</c:f>
                <c:numCache>
                  <c:formatCode>General</c:formatCode>
                  <c:ptCount val="2"/>
                  <c:pt idx="0">
                    <c:v>1.666060172402404</c:v>
                  </c:pt>
                  <c:pt idx="1">
                    <c:v>63.83569527286774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sHKT2;1'!$N$2:$N$3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('OsHKT2;1'!$K$29,'OsHKT2;1'!$K$32)</c:f>
              <c:numCache>
                <c:formatCode>General</c:formatCode>
                <c:ptCount val="2"/>
                <c:pt idx="0">
                  <c:v>2.981969229861765</c:v>
                </c:pt>
                <c:pt idx="1">
                  <c:v>70.9002039125702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95-9041-9D9B-B52B4F849A65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OsHKT2;1'!$L$41,'OsHKT2;1'!$L$44)</c:f>
                <c:numCache>
                  <c:formatCode>General</c:formatCode>
                  <c:ptCount val="2"/>
                  <c:pt idx="0">
                    <c:v>8.7536016080952521</c:v>
                  </c:pt>
                  <c:pt idx="1">
                    <c:v>2.8261915709595278</c:v>
                  </c:pt>
                </c:numCache>
              </c:numRef>
            </c:plus>
            <c:minus>
              <c:numRef>
                <c:f>('OsHKT2;1'!$L$41,'OsHKT2;1'!$L$44)</c:f>
                <c:numCache>
                  <c:formatCode>General</c:formatCode>
                  <c:ptCount val="2"/>
                  <c:pt idx="0">
                    <c:v>8.7536016080952521</c:v>
                  </c:pt>
                  <c:pt idx="1">
                    <c:v>2.826191570959527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sHKT2;1'!$N$2:$N$3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('OsHKT2;1'!$K$41,'OsHKT2;1'!$K$44)</c:f>
              <c:numCache>
                <c:formatCode>General</c:formatCode>
                <c:ptCount val="2"/>
                <c:pt idx="0">
                  <c:v>10.608867261118942</c:v>
                </c:pt>
                <c:pt idx="1">
                  <c:v>15.83275990826638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A95-9041-9D9B-B52B4F849A6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18603999"/>
        <c:axId val="764782447"/>
      </c:barChart>
      <c:catAx>
        <c:axId val="61860399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64782447"/>
        <c:crosses val="autoZero"/>
        <c:auto val="1"/>
        <c:lblAlgn val="ctr"/>
        <c:lblOffset val="100"/>
        <c:noMultiLvlLbl val="0"/>
      </c:catAx>
      <c:valAx>
        <c:axId val="764782447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186039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1;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OsHKT1;3'!$L$29,'OsHKT1;3'!$L$32)</c:f>
                <c:numCache>
                  <c:formatCode>General</c:formatCode>
                  <c:ptCount val="2"/>
                  <c:pt idx="0">
                    <c:v>0.33030062275483524</c:v>
                  </c:pt>
                  <c:pt idx="1">
                    <c:v>0.19538976270814679</c:v>
                  </c:pt>
                </c:numCache>
              </c:numRef>
            </c:plus>
            <c:minus>
              <c:numRef>
                <c:f>('OsHKT1;3'!$L$29,'OsHKT1;3'!$L$32)</c:f>
                <c:numCache>
                  <c:formatCode>General</c:formatCode>
                  <c:ptCount val="2"/>
                  <c:pt idx="0">
                    <c:v>0.33030062275483524</c:v>
                  </c:pt>
                  <c:pt idx="1">
                    <c:v>0.195389762708146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sHKT1;3'!$N$2:$N$3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('OsHKT1;3'!$K$29,'OsHKT1;3'!$K$32)</c:f>
              <c:numCache>
                <c:formatCode>General</c:formatCode>
                <c:ptCount val="2"/>
                <c:pt idx="0">
                  <c:v>0.71530042781962733</c:v>
                </c:pt>
                <c:pt idx="1">
                  <c:v>0.303875147372394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577-B442-B80F-2D3962B3AA12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'OsHKT1;3'!$L$41,'OsHKT1;3'!$L$44)</c:f>
                <c:numCache>
                  <c:formatCode>General</c:formatCode>
                  <c:ptCount val="2"/>
                  <c:pt idx="0">
                    <c:v>1.4264396552944219E-3</c:v>
                  </c:pt>
                  <c:pt idx="1">
                    <c:v>6.4782789065958466E-3</c:v>
                  </c:pt>
                </c:numCache>
              </c:numRef>
            </c:plus>
            <c:minus>
              <c:numRef>
                <c:f>('OsHKT1;3'!$L$41,'OsHKT1;3'!$L$44)</c:f>
                <c:numCache>
                  <c:formatCode>General</c:formatCode>
                  <c:ptCount val="2"/>
                  <c:pt idx="0">
                    <c:v>1.4264396552944219E-3</c:v>
                  </c:pt>
                  <c:pt idx="1">
                    <c:v>6.478278906595846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OsHKT1;3'!$N$2:$N$3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('OsHKT1;3'!$K$41,'OsHKT1;3'!$K$44)</c:f>
              <c:numCache>
                <c:formatCode>General</c:formatCode>
                <c:ptCount val="2"/>
                <c:pt idx="0">
                  <c:v>4.6451285021843315E-3</c:v>
                </c:pt>
                <c:pt idx="1">
                  <c:v>1.468179054906504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577-B442-B80F-2D3962B3AA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68497983"/>
        <c:axId val="768499615"/>
      </c:barChart>
      <c:catAx>
        <c:axId val="76849798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68499615"/>
        <c:crosses val="autoZero"/>
        <c:auto val="1"/>
        <c:lblAlgn val="ctr"/>
        <c:lblOffset val="100"/>
        <c:noMultiLvlLbl val="0"/>
      </c:catAx>
      <c:valAx>
        <c:axId val="768499615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76849798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1;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54:$F$54</c:f>
                <c:numCache>
                  <c:formatCode>General</c:formatCode>
                  <c:ptCount val="4"/>
                  <c:pt idx="0">
                    <c:v>9.0009746385846714E-4</c:v>
                  </c:pt>
                  <c:pt idx="1">
                    <c:v>1.4390041695561557E-2</c:v>
                  </c:pt>
                  <c:pt idx="2">
                    <c:v>7.5365708382526654E-3</c:v>
                  </c:pt>
                  <c:pt idx="3">
                    <c:v>9.3648776464689363E-3</c:v>
                  </c:pt>
                </c:numCache>
              </c:numRef>
            </c:plus>
            <c:minus>
              <c:numRef>
                <c:f>Sheet1!$C$54:$F$54</c:f>
                <c:numCache>
                  <c:formatCode>General</c:formatCode>
                  <c:ptCount val="4"/>
                  <c:pt idx="0">
                    <c:v>9.0009746385846714E-4</c:v>
                  </c:pt>
                  <c:pt idx="1">
                    <c:v>1.4390041695561557E-2</c:v>
                  </c:pt>
                  <c:pt idx="2">
                    <c:v>7.5365708382526654E-3</c:v>
                  </c:pt>
                  <c:pt idx="3">
                    <c:v>9.3648776464689363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28:$E$28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Sheet1!$D$29:$E$29</c:f>
              <c:numCache>
                <c:formatCode>General</c:formatCode>
                <c:ptCount val="2"/>
                <c:pt idx="0">
                  <c:v>4.4580000000000002E-2</c:v>
                </c:pt>
                <c:pt idx="1">
                  <c:v>6.0760000000000002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FBE-5F42-A169-04D5BA708FF8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54:$R$54</c:f>
                <c:numCache>
                  <c:formatCode>General</c:formatCode>
                  <c:ptCount val="4"/>
                  <c:pt idx="0">
                    <c:v>3.5925957808309703E-3</c:v>
                  </c:pt>
                  <c:pt idx="1">
                    <c:v>2.6845297539792707E-3</c:v>
                  </c:pt>
                  <c:pt idx="2">
                    <c:v>6.3902851614340526E-3</c:v>
                  </c:pt>
                  <c:pt idx="3">
                    <c:v>1.2500045777693966E-2</c:v>
                  </c:pt>
                </c:numCache>
              </c:numRef>
            </c:plus>
            <c:minus>
              <c:numRef>
                <c:f>Sheet1!$O$54:$R$54</c:f>
                <c:numCache>
                  <c:formatCode>General</c:formatCode>
                  <c:ptCount val="4"/>
                  <c:pt idx="0">
                    <c:v>3.5925957808309703E-3</c:v>
                  </c:pt>
                  <c:pt idx="1">
                    <c:v>2.6845297539792707E-3</c:v>
                  </c:pt>
                  <c:pt idx="2">
                    <c:v>6.3902851614340526E-3</c:v>
                  </c:pt>
                  <c:pt idx="3">
                    <c:v>1.250004577769396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28:$E$28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Sheet1!$P$29:$Q$29</c:f>
              <c:numCache>
                <c:formatCode>General</c:formatCode>
                <c:ptCount val="2"/>
                <c:pt idx="0">
                  <c:v>3.5929999999999997E-2</c:v>
                </c:pt>
                <c:pt idx="1">
                  <c:v>4.520666666666667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FBE-5F42-A169-04D5BA708F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4079424"/>
        <c:axId val="1074081200"/>
      </c:barChart>
      <c:catAx>
        <c:axId val="10740794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4081200"/>
        <c:crosses val="autoZero"/>
        <c:auto val="1"/>
        <c:lblAlgn val="ctr"/>
        <c:lblOffset val="100"/>
        <c:noMultiLvlLbl val="0"/>
      </c:catAx>
      <c:valAx>
        <c:axId val="1074081200"/>
        <c:scaling>
          <c:orientation val="minMax"/>
        </c:scaling>
        <c:delete val="0"/>
        <c:axPos val="l"/>
        <c:numFmt formatCode="General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407942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1;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55:$F$55</c:f>
                <c:numCache>
                  <c:formatCode>General</c:formatCode>
                  <c:ptCount val="4"/>
                  <c:pt idx="0">
                    <c:v>1.4087504313318869E-3</c:v>
                  </c:pt>
                  <c:pt idx="1">
                    <c:v>2.1322601467300682E-3</c:v>
                  </c:pt>
                  <c:pt idx="2">
                    <c:v>6.7934012099978352E-3</c:v>
                  </c:pt>
                  <c:pt idx="3">
                    <c:v>4.4837744516571396E-2</c:v>
                  </c:pt>
                </c:numCache>
              </c:numRef>
            </c:plus>
            <c:minus>
              <c:numRef>
                <c:f>Sheet1!$C$55:$F$55</c:f>
                <c:numCache>
                  <c:formatCode>General</c:formatCode>
                  <c:ptCount val="4"/>
                  <c:pt idx="0">
                    <c:v>1.4087504313318869E-3</c:v>
                  </c:pt>
                  <c:pt idx="1">
                    <c:v>2.1322601467300682E-3</c:v>
                  </c:pt>
                  <c:pt idx="2">
                    <c:v>6.7934012099978352E-3</c:v>
                  </c:pt>
                  <c:pt idx="3">
                    <c:v>4.483774451657139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28:$Q$28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Sheet1!$D$30:$E$30</c:f>
              <c:numCache>
                <c:formatCode>General</c:formatCode>
                <c:ptCount val="2"/>
                <c:pt idx="0">
                  <c:v>1.6119999999999999E-2</c:v>
                </c:pt>
                <c:pt idx="1">
                  <c:v>2.934000000000000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89A-9E4C-9299-C2812688D32A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55:$R$55</c:f>
                <c:numCache>
                  <c:formatCode>General</c:formatCode>
                  <c:ptCount val="4"/>
                  <c:pt idx="0">
                    <c:v>5.6834525891691391E-3</c:v>
                  </c:pt>
                  <c:pt idx="1">
                    <c:v>4.6571677134403452E-3</c:v>
                  </c:pt>
                  <c:pt idx="2">
                    <c:v>3.9160861839341622E-2</c:v>
                  </c:pt>
                  <c:pt idx="3">
                    <c:v>2.7116268384700552E-2</c:v>
                  </c:pt>
                </c:numCache>
              </c:numRef>
            </c:plus>
            <c:minus>
              <c:numRef>
                <c:f>Sheet1!$O$55:$R$55</c:f>
                <c:numCache>
                  <c:formatCode>General</c:formatCode>
                  <c:ptCount val="4"/>
                  <c:pt idx="0">
                    <c:v>5.6834525891691391E-3</c:v>
                  </c:pt>
                  <c:pt idx="1">
                    <c:v>4.6571677134403452E-3</c:v>
                  </c:pt>
                  <c:pt idx="2">
                    <c:v>3.9160861839341622E-2</c:v>
                  </c:pt>
                  <c:pt idx="3">
                    <c:v>2.711626838470055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28:$Q$28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Sheet1!$P$30:$Q$30</c:f>
              <c:numCache>
                <c:formatCode>General</c:formatCode>
                <c:ptCount val="2"/>
                <c:pt idx="0">
                  <c:v>1.8056666666666665E-2</c:v>
                </c:pt>
                <c:pt idx="1">
                  <c:v>0.15468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89A-9E4C-9299-C2812688D32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4104688"/>
        <c:axId val="1074107008"/>
      </c:barChart>
      <c:catAx>
        <c:axId val="1074104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4107008"/>
        <c:crosses val="autoZero"/>
        <c:auto val="1"/>
        <c:lblAlgn val="ctr"/>
        <c:lblOffset val="100"/>
        <c:noMultiLvlLbl val="0"/>
      </c:catAx>
      <c:valAx>
        <c:axId val="107410700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4104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1;5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56:$F$56</c:f>
                <c:numCache>
                  <c:formatCode>General</c:formatCode>
                  <c:ptCount val="4"/>
                  <c:pt idx="0">
                    <c:v>1.4309980588541852E-2</c:v>
                  </c:pt>
                  <c:pt idx="1">
                    <c:v>7.7947874320670837E-2</c:v>
                  </c:pt>
                  <c:pt idx="2">
                    <c:v>2.6305026980492616E-2</c:v>
                  </c:pt>
                  <c:pt idx="3">
                    <c:v>7.4635879069281708E-2</c:v>
                  </c:pt>
                </c:numCache>
              </c:numRef>
            </c:plus>
            <c:minus>
              <c:numRef>
                <c:f>Sheet1!$C$56:$F$56</c:f>
                <c:numCache>
                  <c:formatCode>General</c:formatCode>
                  <c:ptCount val="4"/>
                  <c:pt idx="0">
                    <c:v>1.4309980588541852E-2</c:v>
                  </c:pt>
                  <c:pt idx="1">
                    <c:v>7.7947874320670837E-2</c:v>
                  </c:pt>
                  <c:pt idx="2">
                    <c:v>2.6305026980492616E-2</c:v>
                  </c:pt>
                  <c:pt idx="3">
                    <c:v>7.463587906928170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28:$Q$28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Sheet1!$D$31:$E$31</c:f>
              <c:numCache>
                <c:formatCode>General</c:formatCode>
                <c:ptCount val="2"/>
                <c:pt idx="0">
                  <c:v>0.55523333333333336</c:v>
                </c:pt>
                <c:pt idx="1">
                  <c:v>0.43283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00A-7648-9CD3-6BF4BC54EE17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56:$R$56</c:f>
                <c:numCache>
                  <c:formatCode>General</c:formatCode>
                  <c:ptCount val="4"/>
                  <c:pt idx="0">
                    <c:v>2.1225953714995006E-2</c:v>
                  </c:pt>
                  <c:pt idx="1">
                    <c:v>7.6869680484426398E-2</c:v>
                  </c:pt>
                  <c:pt idx="2">
                    <c:v>0.10702720837867971</c:v>
                  </c:pt>
                  <c:pt idx="3">
                    <c:v>0.22489319193292126</c:v>
                  </c:pt>
                </c:numCache>
              </c:numRef>
            </c:plus>
            <c:minus>
              <c:numRef>
                <c:f>Sheet1!$O$56:$R$56</c:f>
                <c:numCache>
                  <c:formatCode>General</c:formatCode>
                  <c:ptCount val="4"/>
                  <c:pt idx="0">
                    <c:v>2.1225953714995006E-2</c:v>
                  </c:pt>
                  <c:pt idx="1">
                    <c:v>7.6869680484426398E-2</c:v>
                  </c:pt>
                  <c:pt idx="2">
                    <c:v>0.10702720837867971</c:v>
                  </c:pt>
                  <c:pt idx="3">
                    <c:v>0.224893191932921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28:$Q$28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Sheet1!$P$31:$Q$31</c:f>
              <c:numCache>
                <c:formatCode>General</c:formatCode>
                <c:ptCount val="2"/>
                <c:pt idx="0">
                  <c:v>0.74176666666666657</c:v>
                </c:pt>
                <c:pt idx="1">
                  <c:v>0.722300000000000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200A-7648-9CD3-6BF4BC54EE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4132288"/>
        <c:axId val="1074134608"/>
      </c:barChart>
      <c:catAx>
        <c:axId val="1074132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4134608"/>
        <c:crosses val="autoZero"/>
        <c:auto val="1"/>
        <c:lblAlgn val="ctr"/>
        <c:lblOffset val="100"/>
        <c:noMultiLvlLbl val="0"/>
      </c:catAx>
      <c:valAx>
        <c:axId val="1074134608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41322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NHX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57:$F$57</c:f>
                <c:numCache>
                  <c:formatCode>General</c:formatCode>
                  <c:ptCount val="4"/>
                  <c:pt idx="0">
                    <c:v>0.16023802087311678</c:v>
                  </c:pt>
                  <c:pt idx="1">
                    <c:v>1.1146821669576197</c:v>
                  </c:pt>
                  <c:pt idx="2">
                    <c:v>0.19213045336726595</c:v>
                  </c:pt>
                  <c:pt idx="3">
                    <c:v>0.14491645102533307</c:v>
                  </c:pt>
                </c:numCache>
              </c:numRef>
            </c:plus>
            <c:minus>
              <c:numRef>
                <c:f>Sheet1!$C$57:$F$57</c:f>
                <c:numCache>
                  <c:formatCode>General</c:formatCode>
                  <c:ptCount val="4"/>
                  <c:pt idx="0">
                    <c:v>0.16023802087311678</c:v>
                  </c:pt>
                  <c:pt idx="1">
                    <c:v>1.1146821669576197</c:v>
                  </c:pt>
                  <c:pt idx="2">
                    <c:v>0.19213045336726595</c:v>
                  </c:pt>
                  <c:pt idx="3">
                    <c:v>0.1449164510253330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28:$Q$28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Sheet1!$D$32:$E$32</c:f>
              <c:numCache>
                <c:formatCode>General</c:formatCode>
                <c:ptCount val="2"/>
                <c:pt idx="0">
                  <c:v>6.468</c:v>
                </c:pt>
                <c:pt idx="1">
                  <c:v>4.912666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62F-E64F-BFD1-76AE10768AAE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57:$R$57</c:f>
                <c:numCache>
                  <c:formatCode>General</c:formatCode>
                  <c:ptCount val="4"/>
                  <c:pt idx="0">
                    <c:v>0.31447646087496683</c:v>
                  </c:pt>
                  <c:pt idx="1">
                    <c:v>0.21588757362211566</c:v>
                  </c:pt>
                  <c:pt idx="2">
                    <c:v>0.17437411887471671</c:v>
                  </c:pt>
                  <c:pt idx="3">
                    <c:v>0.15018359135108963</c:v>
                  </c:pt>
                </c:numCache>
              </c:numRef>
            </c:plus>
            <c:minus>
              <c:numRef>
                <c:f>Sheet1!$O$57:$R$57</c:f>
                <c:numCache>
                  <c:formatCode>General</c:formatCode>
                  <c:ptCount val="4"/>
                  <c:pt idx="0">
                    <c:v>0.31447646087496683</c:v>
                  </c:pt>
                  <c:pt idx="1">
                    <c:v>0.21588757362211566</c:v>
                  </c:pt>
                  <c:pt idx="2">
                    <c:v>0.17437411887471671</c:v>
                  </c:pt>
                  <c:pt idx="3">
                    <c:v>0.150183591351089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28:$Q$28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Sheet1!$P$32:$Q$32</c:f>
              <c:numCache>
                <c:formatCode>General</c:formatCode>
                <c:ptCount val="2"/>
                <c:pt idx="0">
                  <c:v>3.2406666666666673</c:v>
                </c:pt>
                <c:pt idx="1">
                  <c:v>2.076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62F-E64F-BFD1-76AE10768A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4160176"/>
        <c:axId val="1074162496"/>
      </c:barChart>
      <c:catAx>
        <c:axId val="10741601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4162496"/>
        <c:crosses val="autoZero"/>
        <c:auto val="1"/>
        <c:lblAlgn val="ctr"/>
        <c:lblOffset val="100"/>
        <c:noMultiLvlLbl val="0"/>
      </c:catAx>
      <c:valAx>
        <c:axId val="107416249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41601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NHX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C$58:$F$58</c:f>
                <c:numCache>
                  <c:formatCode>General</c:formatCode>
                  <c:ptCount val="4"/>
                  <c:pt idx="0">
                    <c:v>2.4033610724242906E-2</c:v>
                  </c:pt>
                  <c:pt idx="1">
                    <c:v>4.5018304918974655E-2</c:v>
                  </c:pt>
                  <c:pt idx="2">
                    <c:v>7.0514773865717917E-2</c:v>
                  </c:pt>
                  <c:pt idx="3">
                    <c:v>0.33809663312924809</c:v>
                  </c:pt>
                </c:numCache>
              </c:numRef>
            </c:plus>
            <c:minus>
              <c:numRef>
                <c:f>Sheet1!$C$58:$F$58</c:f>
                <c:numCache>
                  <c:formatCode>General</c:formatCode>
                  <c:ptCount val="4"/>
                  <c:pt idx="0">
                    <c:v>2.4033610724242906E-2</c:v>
                  </c:pt>
                  <c:pt idx="1">
                    <c:v>4.5018304918974655E-2</c:v>
                  </c:pt>
                  <c:pt idx="2">
                    <c:v>7.0514773865717917E-2</c:v>
                  </c:pt>
                  <c:pt idx="3">
                    <c:v>0.338096633129248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28:$Q$28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Sheet1!$D$33:$E$33</c:f>
              <c:numCache>
                <c:formatCode>General</c:formatCode>
                <c:ptCount val="2"/>
                <c:pt idx="0">
                  <c:v>0.99623333333333342</c:v>
                </c:pt>
                <c:pt idx="1">
                  <c:v>1.209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00B-9742-A28A-E9B672213DF9}"/>
            </c:ext>
          </c:extLst>
        </c:ser>
        <c:ser>
          <c:idx val="1"/>
          <c:order val="1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58:$R$58</c:f>
                <c:numCache>
                  <c:formatCode>General</c:formatCode>
                  <c:ptCount val="4"/>
                  <c:pt idx="0">
                    <c:v>6.6493942915459958E-2</c:v>
                  </c:pt>
                  <c:pt idx="1">
                    <c:v>5.5477723256977226E-3</c:v>
                  </c:pt>
                  <c:pt idx="2">
                    <c:v>3.4690696799638439E-2</c:v>
                  </c:pt>
                  <c:pt idx="3">
                    <c:v>7.8148007723237031E-2</c:v>
                  </c:pt>
                </c:numCache>
              </c:numRef>
            </c:plus>
            <c:minus>
              <c:numRef>
                <c:f>Sheet1!$O$58:$R$58</c:f>
                <c:numCache>
                  <c:formatCode>General</c:formatCode>
                  <c:ptCount val="4"/>
                  <c:pt idx="0">
                    <c:v>6.6493942915459958E-2</c:v>
                  </c:pt>
                  <c:pt idx="1">
                    <c:v>5.5477723256977226E-3</c:v>
                  </c:pt>
                  <c:pt idx="2">
                    <c:v>3.4690696799638439E-2</c:v>
                  </c:pt>
                  <c:pt idx="3">
                    <c:v>7.814800772323703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P$28:$Q$28</c:f>
              <c:strCache>
                <c:ptCount val="2"/>
                <c:pt idx="0">
                  <c:v>Sheath2</c:v>
                </c:pt>
                <c:pt idx="1">
                  <c:v>Sheath3</c:v>
                </c:pt>
              </c:strCache>
            </c:strRef>
          </c:cat>
          <c:val>
            <c:numRef>
              <c:f>Sheet1!$P$33:$Q$33</c:f>
              <c:numCache>
                <c:formatCode>General</c:formatCode>
                <c:ptCount val="2"/>
                <c:pt idx="0">
                  <c:v>1.3226666666666667</c:v>
                </c:pt>
                <c:pt idx="1">
                  <c:v>1.4783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00B-9742-A28A-E9B672213D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076399664"/>
        <c:axId val="1076401984"/>
      </c:barChart>
      <c:catAx>
        <c:axId val="1076399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6401984"/>
        <c:crosses val="autoZero"/>
        <c:auto val="1"/>
        <c:lblAlgn val="ctr"/>
        <c:lblOffset val="100"/>
        <c:noMultiLvlLbl val="0"/>
      </c:catAx>
      <c:valAx>
        <c:axId val="1076401984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10763996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500"/>
            </a:lvl2pPr>
            <a:lvl3pPr marL="685772" indent="0" algn="ctr">
              <a:buNone/>
              <a:defRPr sz="1350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199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799801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55463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9114313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2814285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7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957725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2235281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500" b="1"/>
            </a:lvl2pPr>
            <a:lvl3pPr marL="685772" indent="0">
              <a:buNone/>
              <a:defRPr sz="1350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199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9495377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8650046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1637925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5373585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86" indent="0">
              <a:buNone/>
              <a:defRPr sz="2100"/>
            </a:lvl2pPr>
            <a:lvl3pPr marL="685772" indent="0">
              <a:buNone/>
              <a:defRPr sz="1800"/>
            </a:lvl3pPr>
            <a:lvl4pPr marL="1028657" indent="0">
              <a:buNone/>
              <a:defRPr sz="1500"/>
            </a:lvl4pPr>
            <a:lvl5pPr marL="1371543" indent="0">
              <a:buNone/>
              <a:defRPr sz="1500"/>
            </a:lvl5pPr>
            <a:lvl6pPr marL="1714428" indent="0">
              <a:buNone/>
              <a:defRPr sz="1500"/>
            </a:lvl6pPr>
            <a:lvl7pPr marL="2057314" indent="0">
              <a:buNone/>
              <a:defRPr sz="1500"/>
            </a:lvl7pPr>
            <a:lvl8pPr marL="2400199" indent="0">
              <a:buNone/>
              <a:defRPr sz="1500"/>
            </a:lvl8pPr>
            <a:lvl9pPr marL="2743085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2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199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18676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64542F-8E23-6F42-B096-A3458220FF9B}" type="datetimeFigureOut">
              <a:rPr lang="en-JP" smtClean="0"/>
              <a:t>08/13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657373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5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2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72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99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4" name="Chart 33">
            <a:extLst>
              <a:ext uri="{FF2B5EF4-FFF2-40B4-BE49-F238E27FC236}">
                <a16:creationId xmlns:a16="http://schemas.microsoft.com/office/drawing/2014/main" id="{C69E642E-FD16-AE47-8CA7-0E0EC31EE79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02795895"/>
              </p:ext>
            </p:extLst>
          </p:nvPr>
        </p:nvGraphicFramePr>
        <p:xfrm>
          <a:off x="3451180" y="2393893"/>
          <a:ext cx="1543874" cy="18341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3" name="Chart 32">
            <a:extLst>
              <a:ext uri="{FF2B5EF4-FFF2-40B4-BE49-F238E27FC236}">
                <a16:creationId xmlns:a16="http://schemas.microsoft.com/office/drawing/2014/main" id="{15B0C890-9FF6-D749-8657-484B8A5E7D66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90516571"/>
              </p:ext>
            </p:extLst>
          </p:nvPr>
        </p:nvGraphicFramePr>
        <p:xfrm>
          <a:off x="1821196" y="2403576"/>
          <a:ext cx="1543874" cy="18269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2" name="Chart 31">
            <a:extLst>
              <a:ext uri="{FF2B5EF4-FFF2-40B4-BE49-F238E27FC236}">
                <a16:creationId xmlns:a16="http://schemas.microsoft.com/office/drawing/2014/main" id="{C98B78E8-0445-7B41-A1B3-ABB230C316B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8291681"/>
              </p:ext>
            </p:extLst>
          </p:nvPr>
        </p:nvGraphicFramePr>
        <p:xfrm>
          <a:off x="196664" y="2397614"/>
          <a:ext cx="1543874" cy="18328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1" name="Chart 30">
            <a:extLst>
              <a:ext uri="{FF2B5EF4-FFF2-40B4-BE49-F238E27FC236}">
                <a16:creationId xmlns:a16="http://schemas.microsoft.com/office/drawing/2014/main" id="{CF2A4FB6-E566-DA46-B13E-2A4BF7B8188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08731580"/>
              </p:ext>
            </p:extLst>
          </p:nvPr>
        </p:nvGraphicFramePr>
        <p:xfrm>
          <a:off x="1821339" y="481284"/>
          <a:ext cx="1536756" cy="184231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7796242"/>
              </p:ext>
            </p:extLst>
          </p:nvPr>
        </p:nvGraphicFramePr>
        <p:xfrm>
          <a:off x="199479" y="489900"/>
          <a:ext cx="1537224" cy="18383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00000000-0008-0000-00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9625338"/>
              </p:ext>
            </p:extLst>
          </p:nvPr>
        </p:nvGraphicFramePr>
        <p:xfrm>
          <a:off x="3446509" y="484812"/>
          <a:ext cx="1537224" cy="18433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00000000-0008-0000-00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79240955"/>
              </p:ext>
            </p:extLst>
          </p:nvPr>
        </p:nvGraphicFramePr>
        <p:xfrm>
          <a:off x="5060355" y="489423"/>
          <a:ext cx="1543874" cy="18341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00000000-0008-0000-0000-000005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59397006"/>
              </p:ext>
            </p:extLst>
          </p:nvPr>
        </p:nvGraphicFramePr>
        <p:xfrm>
          <a:off x="5057530" y="2397195"/>
          <a:ext cx="1543874" cy="18341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00000000-0008-0000-0000-000006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5131981"/>
              </p:ext>
            </p:extLst>
          </p:nvPr>
        </p:nvGraphicFramePr>
        <p:xfrm>
          <a:off x="199947" y="4323407"/>
          <a:ext cx="1537224" cy="18341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00000000-0008-0000-0000-000007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84876350"/>
              </p:ext>
            </p:extLst>
          </p:nvPr>
        </p:nvGraphicFramePr>
        <p:xfrm>
          <a:off x="1814985" y="4323407"/>
          <a:ext cx="1537223" cy="18341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00000000-0008-0000-0000-000008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93477016"/>
              </p:ext>
            </p:extLst>
          </p:nvPr>
        </p:nvGraphicFramePr>
        <p:xfrm>
          <a:off x="5057530" y="4320670"/>
          <a:ext cx="1543874" cy="18341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00000000-0008-0000-0000-000009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4552416"/>
              </p:ext>
            </p:extLst>
          </p:nvPr>
        </p:nvGraphicFramePr>
        <p:xfrm>
          <a:off x="199480" y="6241171"/>
          <a:ext cx="1537223" cy="18341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6" name="Chart 15">
            <a:extLst>
              <a:ext uri="{FF2B5EF4-FFF2-40B4-BE49-F238E27FC236}">
                <a16:creationId xmlns:a16="http://schemas.microsoft.com/office/drawing/2014/main" id="{1E484E59-4086-7846-B249-6965B6C34F6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8409946"/>
              </p:ext>
            </p:extLst>
          </p:nvPr>
        </p:nvGraphicFramePr>
        <p:xfrm>
          <a:off x="3443924" y="4320670"/>
          <a:ext cx="1537223" cy="18341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000F6B8A-6A1C-8D4D-885B-E8CE730CC819}"/>
              </a:ext>
            </a:extLst>
          </p:cNvPr>
          <p:cNvSpPr txBox="1"/>
          <p:nvPr/>
        </p:nvSpPr>
        <p:spPr>
          <a:xfrm>
            <a:off x="199479" y="485594"/>
            <a:ext cx="29527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3DA47AF-9A30-3D45-9A19-905810F4C088}"/>
              </a:ext>
            </a:extLst>
          </p:cNvPr>
          <p:cNvSpPr txBox="1"/>
          <p:nvPr/>
        </p:nvSpPr>
        <p:spPr>
          <a:xfrm>
            <a:off x="1813173" y="481284"/>
            <a:ext cx="287258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58FE674-E747-AC4F-91A3-31E4ECE24FCB}"/>
              </a:ext>
            </a:extLst>
          </p:cNvPr>
          <p:cNvSpPr txBox="1"/>
          <p:nvPr/>
        </p:nvSpPr>
        <p:spPr>
          <a:xfrm>
            <a:off x="199479" y="2400992"/>
            <a:ext cx="27924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3A5DFB8-51E9-6746-B896-04EDF65B9D7E}"/>
              </a:ext>
            </a:extLst>
          </p:cNvPr>
          <p:cNvSpPr txBox="1"/>
          <p:nvPr/>
        </p:nvSpPr>
        <p:spPr>
          <a:xfrm>
            <a:off x="3451180" y="484811"/>
            <a:ext cx="287258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A578A5E-FDBC-9748-906E-14DC58557BAB}"/>
              </a:ext>
            </a:extLst>
          </p:cNvPr>
          <p:cNvSpPr txBox="1"/>
          <p:nvPr/>
        </p:nvSpPr>
        <p:spPr>
          <a:xfrm>
            <a:off x="5057954" y="489993"/>
            <a:ext cx="29527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39530D4D-F341-DC49-A29A-50C8E9D2926D}"/>
              </a:ext>
            </a:extLst>
          </p:cNvPr>
          <p:cNvSpPr txBox="1"/>
          <p:nvPr/>
        </p:nvSpPr>
        <p:spPr>
          <a:xfrm>
            <a:off x="1821339" y="2401115"/>
            <a:ext cx="269626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A56705C-241D-7448-A393-549A1BC5FF93}"/>
              </a:ext>
            </a:extLst>
          </p:cNvPr>
          <p:cNvSpPr txBox="1"/>
          <p:nvPr/>
        </p:nvSpPr>
        <p:spPr>
          <a:xfrm>
            <a:off x="3443924" y="2400992"/>
            <a:ext cx="29527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7FF1FD7-519C-DA47-9E38-BFD5B5BE64BA}"/>
              </a:ext>
            </a:extLst>
          </p:cNvPr>
          <p:cNvSpPr txBox="1"/>
          <p:nvPr/>
        </p:nvSpPr>
        <p:spPr>
          <a:xfrm>
            <a:off x="5060001" y="2393893"/>
            <a:ext cx="304892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1F63B0B-16DC-4449-8125-9055CEC5EE4B}"/>
              </a:ext>
            </a:extLst>
          </p:cNvPr>
          <p:cNvSpPr txBox="1"/>
          <p:nvPr/>
        </p:nvSpPr>
        <p:spPr>
          <a:xfrm>
            <a:off x="202317" y="4332244"/>
            <a:ext cx="235962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105045E-05D6-F54D-93A7-FF715B403420}"/>
              </a:ext>
            </a:extLst>
          </p:cNvPr>
          <p:cNvSpPr txBox="1"/>
          <p:nvPr/>
        </p:nvSpPr>
        <p:spPr>
          <a:xfrm>
            <a:off x="1813325" y="4332244"/>
            <a:ext cx="243978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F43E84F-3CFE-4A45-B62E-2AB336377084}"/>
              </a:ext>
            </a:extLst>
          </p:cNvPr>
          <p:cNvSpPr txBox="1"/>
          <p:nvPr/>
        </p:nvSpPr>
        <p:spPr>
          <a:xfrm>
            <a:off x="3451180" y="4320669"/>
            <a:ext cx="29527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8E70A56-AD33-9E40-96EB-A6410141BCAD}"/>
              </a:ext>
            </a:extLst>
          </p:cNvPr>
          <p:cNvSpPr txBox="1"/>
          <p:nvPr/>
        </p:nvSpPr>
        <p:spPr>
          <a:xfrm>
            <a:off x="5060001" y="4320669"/>
            <a:ext cx="279244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B7EC5AE-D0A6-294F-92E4-F5F991BD156F}"/>
              </a:ext>
            </a:extLst>
          </p:cNvPr>
          <p:cNvSpPr txBox="1"/>
          <p:nvPr/>
        </p:nvSpPr>
        <p:spPr>
          <a:xfrm>
            <a:off x="196664" y="6241171"/>
            <a:ext cx="320922" cy="276999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901BB60-F7A6-5D48-B944-D7050D55E87C}"/>
              </a:ext>
            </a:extLst>
          </p:cNvPr>
          <p:cNvSpPr txBox="1"/>
          <p:nvPr/>
        </p:nvSpPr>
        <p:spPr>
          <a:xfrm>
            <a:off x="4538546" y="952097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FF3CB4F-4B12-0742-9B01-40A802615368}"/>
              </a:ext>
            </a:extLst>
          </p:cNvPr>
          <p:cNvSpPr txBox="1"/>
          <p:nvPr/>
        </p:nvSpPr>
        <p:spPr>
          <a:xfrm>
            <a:off x="5556706" y="319645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1EBBC6AC-03C1-DD4D-91BE-EC6ADD5FAB17}"/>
              </a:ext>
            </a:extLst>
          </p:cNvPr>
          <p:cNvSpPr txBox="1"/>
          <p:nvPr/>
        </p:nvSpPr>
        <p:spPr>
          <a:xfrm>
            <a:off x="6130932" y="3407293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AA12EA86-0B32-5C43-AD08-0253B6A17DEB}"/>
              </a:ext>
            </a:extLst>
          </p:cNvPr>
          <p:cNvSpPr txBox="1"/>
          <p:nvPr/>
        </p:nvSpPr>
        <p:spPr>
          <a:xfrm>
            <a:off x="751085" y="491616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89B3623-5F41-0247-B056-5FD320257DFA}"/>
              </a:ext>
            </a:extLst>
          </p:cNvPr>
          <p:cNvSpPr txBox="1"/>
          <p:nvPr/>
        </p:nvSpPr>
        <p:spPr>
          <a:xfrm>
            <a:off x="1276179" y="485414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6CA42CF8-9437-914D-B436-15BBBE3FFFA1}"/>
              </a:ext>
            </a:extLst>
          </p:cNvPr>
          <p:cNvGrpSpPr/>
          <p:nvPr/>
        </p:nvGrpSpPr>
        <p:grpSpPr>
          <a:xfrm>
            <a:off x="1959699" y="6335501"/>
            <a:ext cx="1216866" cy="720333"/>
            <a:chOff x="0" y="16318"/>
            <a:chExt cx="666992" cy="392061"/>
          </a:xfrm>
        </p:grpSpPr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225A517D-3BDF-6644-9A91-6E4662C1F641}"/>
                </a:ext>
              </a:extLst>
            </p:cNvPr>
            <p:cNvSpPr/>
            <p:nvPr/>
          </p:nvSpPr>
          <p:spPr>
            <a:xfrm>
              <a:off x="0" y="193948"/>
              <a:ext cx="132646" cy="123268"/>
            </a:xfrm>
            <a:prstGeom prst="rect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2600"/>
            </a:p>
          </p:txBody>
        </p:sp>
        <p:sp>
          <p:nvSpPr>
            <p:cNvPr id="44" name="TextBox 162">
              <a:extLst>
                <a:ext uri="{FF2B5EF4-FFF2-40B4-BE49-F238E27FC236}">
                  <a16:creationId xmlns:a16="http://schemas.microsoft.com/office/drawing/2014/main" id="{EAC6F418-5FEF-1141-97CE-8B308124D14F}"/>
                </a:ext>
              </a:extLst>
            </p:cNvPr>
            <p:cNvSpPr txBox="1"/>
            <p:nvPr/>
          </p:nvSpPr>
          <p:spPr>
            <a:xfrm>
              <a:off x="109302" y="16318"/>
              <a:ext cx="557690" cy="22436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Helvetica" pitchFamily="2" charset="0"/>
                  <a:cs typeface="Arial Unicode MS" panose="020B0604020202020204" pitchFamily="34" charset="-128"/>
                </a:rPr>
                <a:t>Control</a:t>
              </a:r>
              <a:r>
                <a:rPr lang="en-US" sz="1400" dirty="0">
                  <a:solidFill>
                    <a:srgbClr val="000000"/>
                  </a:solidFill>
                  <a:latin typeface="Helvetica" pitchFamily="2" charset="0"/>
                  <a:ea typeface="Helvetica" pitchFamily="2" charset="0"/>
                  <a:cs typeface="Helvetica" pitchFamily="2" charset="0"/>
                </a:rPr>
                <a:t> </a:t>
              </a:r>
              <a:endParaRPr lang="en-JP" sz="1400" dirty="0">
                <a:latin typeface="Calibri" panose="020F0502020204030204" pitchFamily="34" charset="0"/>
                <a:ea typeface="Yu Mincho" panose="02020400000000000000" pitchFamily="18" charset="-128"/>
                <a:cs typeface="Arial Unicode MS" panose="020B0604020202020204" pitchFamily="34" charset="-128"/>
              </a:endParaRPr>
            </a:p>
          </p:txBody>
        </p:sp>
        <p:sp>
          <p:nvSpPr>
            <p:cNvPr id="45" name="TextBox 163">
              <a:extLst>
                <a:ext uri="{FF2B5EF4-FFF2-40B4-BE49-F238E27FC236}">
                  <a16:creationId xmlns:a16="http://schemas.microsoft.com/office/drawing/2014/main" id="{F5F16374-02F3-FB49-A86F-DB807BC9C5C6}"/>
                </a:ext>
              </a:extLst>
            </p:cNvPr>
            <p:cNvSpPr txBox="1"/>
            <p:nvPr/>
          </p:nvSpPr>
          <p:spPr>
            <a:xfrm>
              <a:off x="119964" y="184018"/>
              <a:ext cx="427536" cy="224361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r>
                <a:rPr lang="en-US" sz="1400" dirty="0">
                  <a:solidFill>
                    <a:srgbClr val="000000"/>
                  </a:solidFill>
                  <a:latin typeface="Times New Roman" panose="02020603050405020304" pitchFamily="18" charset="0"/>
                  <a:ea typeface="Helvetica" pitchFamily="2" charset="0"/>
                  <a:cs typeface="Arial Unicode MS" panose="020B0604020202020204" pitchFamily="34" charset="-128"/>
                </a:rPr>
                <a:t>NaCl </a:t>
              </a:r>
              <a:endParaRPr lang="en-JP" sz="1400" dirty="0">
                <a:latin typeface="Calibri" panose="020F0502020204030204" pitchFamily="34" charset="0"/>
                <a:ea typeface="Yu Mincho" panose="02020400000000000000" pitchFamily="18" charset="-128"/>
                <a:cs typeface="Arial Unicode MS" panose="020B0604020202020204" pitchFamily="34" charset="-128"/>
              </a:endParaRPr>
            </a:p>
          </p:txBody>
        </p:sp>
        <p:sp>
          <p:nvSpPr>
            <p:cNvPr id="46" name="Rectangle 45">
              <a:extLst>
                <a:ext uri="{FF2B5EF4-FFF2-40B4-BE49-F238E27FC236}">
                  <a16:creationId xmlns:a16="http://schemas.microsoft.com/office/drawing/2014/main" id="{1A2ACC17-1C67-5B48-93D1-2C1D1655A8B1}"/>
                </a:ext>
              </a:extLst>
            </p:cNvPr>
            <p:cNvSpPr/>
            <p:nvPr/>
          </p:nvSpPr>
          <p:spPr>
            <a:xfrm>
              <a:off x="0" y="25283"/>
              <a:ext cx="132646" cy="12969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endParaRPr lang="en-US" sz="2600"/>
            </a:p>
          </p:txBody>
        </p:sp>
      </p:grpSp>
      <p:sp>
        <p:nvSpPr>
          <p:cNvPr id="47" name="テキスト ボックス 34">
            <a:extLst>
              <a:ext uri="{FF2B5EF4-FFF2-40B4-BE49-F238E27FC236}">
                <a16:creationId xmlns:a16="http://schemas.microsoft.com/office/drawing/2014/main" id="{30E329F3-CC7A-9046-B24E-2D7880DAE70F}"/>
              </a:ext>
            </a:extLst>
          </p:cNvPr>
          <p:cNvSpPr txBox="1"/>
          <p:nvPr/>
        </p:nvSpPr>
        <p:spPr>
          <a:xfrm>
            <a:off x="605600" y="2036585"/>
            <a:ext cx="1028648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dle    Apic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テキスト ボックス 34">
            <a:extLst>
              <a:ext uri="{FF2B5EF4-FFF2-40B4-BE49-F238E27FC236}">
                <a16:creationId xmlns:a16="http://schemas.microsoft.com/office/drawing/2014/main" id="{30B3B716-4C30-D741-AFDE-5354929E1781}"/>
              </a:ext>
            </a:extLst>
          </p:cNvPr>
          <p:cNvSpPr txBox="1"/>
          <p:nvPr/>
        </p:nvSpPr>
        <p:spPr>
          <a:xfrm>
            <a:off x="2169653" y="2033014"/>
            <a:ext cx="1028648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dle    Apic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テキスト ボックス 34">
            <a:extLst>
              <a:ext uri="{FF2B5EF4-FFF2-40B4-BE49-F238E27FC236}">
                <a16:creationId xmlns:a16="http://schemas.microsoft.com/office/drawing/2014/main" id="{99F9C027-B784-7441-8993-6B02DE8512F4}"/>
              </a:ext>
            </a:extLst>
          </p:cNvPr>
          <p:cNvSpPr txBox="1"/>
          <p:nvPr/>
        </p:nvSpPr>
        <p:spPr>
          <a:xfrm>
            <a:off x="3877803" y="2036584"/>
            <a:ext cx="1028648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dle    Apic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テキスト ボックス 34">
            <a:extLst>
              <a:ext uri="{FF2B5EF4-FFF2-40B4-BE49-F238E27FC236}">
                <a16:creationId xmlns:a16="http://schemas.microsoft.com/office/drawing/2014/main" id="{7FCD5440-D014-BA43-9B77-5693D6FB525A}"/>
              </a:ext>
            </a:extLst>
          </p:cNvPr>
          <p:cNvSpPr txBox="1"/>
          <p:nvPr/>
        </p:nvSpPr>
        <p:spPr>
          <a:xfrm>
            <a:off x="5440220" y="2033073"/>
            <a:ext cx="1028648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dle    Apic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34">
            <a:extLst>
              <a:ext uri="{FF2B5EF4-FFF2-40B4-BE49-F238E27FC236}">
                <a16:creationId xmlns:a16="http://schemas.microsoft.com/office/drawing/2014/main" id="{A692A1D6-8E00-894D-B730-7536CF927D23}"/>
              </a:ext>
            </a:extLst>
          </p:cNvPr>
          <p:cNvSpPr txBox="1"/>
          <p:nvPr/>
        </p:nvSpPr>
        <p:spPr>
          <a:xfrm>
            <a:off x="595872" y="3935846"/>
            <a:ext cx="1028648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dle    Apic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テキスト ボックス 34">
            <a:extLst>
              <a:ext uri="{FF2B5EF4-FFF2-40B4-BE49-F238E27FC236}">
                <a16:creationId xmlns:a16="http://schemas.microsoft.com/office/drawing/2014/main" id="{77243787-11BF-E546-B03C-838DAF66DE10}"/>
              </a:ext>
            </a:extLst>
          </p:cNvPr>
          <p:cNvSpPr txBox="1"/>
          <p:nvPr/>
        </p:nvSpPr>
        <p:spPr>
          <a:xfrm>
            <a:off x="2100431" y="3941718"/>
            <a:ext cx="1028648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dle    Apic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テキスト ボックス 34">
            <a:extLst>
              <a:ext uri="{FF2B5EF4-FFF2-40B4-BE49-F238E27FC236}">
                <a16:creationId xmlns:a16="http://schemas.microsoft.com/office/drawing/2014/main" id="{A40932CA-BD9F-F74A-8677-3DD2566375ED}"/>
              </a:ext>
            </a:extLst>
          </p:cNvPr>
          <p:cNvSpPr txBox="1"/>
          <p:nvPr/>
        </p:nvSpPr>
        <p:spPr>
          <a:xfrm>
            <a:off x="3802619" y="3941610"/>
            <a:ext cx="1028648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dle    Apic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テキスト ボックス 34">
            <a:extLst>
              <a:ext uri="{FF2B5EF4-FFF2-40B4-BE49-F238E27FC236}">
                <a16:creationId xmlns:a16="http://schemas.microsoft.com/office/drawing/2014/main" id="{4EA53CCF-6C44-1D41-814B-038909021D50}"/>
              </a:ext>
            </a:extLst>
          </p:cNvPr>
          <p:cNvSpPr txBox="1"/>
          <p:nvPr/>
        </p:nvSpPr>
        <p:spPr>
          <a:xfrm>
            <a:off x="5374620" y="3940963"/>
            <a:ext cx="1180049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dle     Apic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テキスト ボックス 34">
            <a:extLst>
              <a:ext uri="{FF2B5EF4-FFF2-40B4-BE49-F238E27FC236}">
                <a16:creationId xmlns:a16="http://schemas.microsoft.com/office/drawing/2014/main" id="{1D674C0D-AE7E-EF44-B8DE-E4BB1347C4F6}"/>
              </a:ext>
            </a:extLst>
          </p:cNvPr>
          <p:cNvSpPr txBox="1"/>
          <p:nvPr/>
        </p:nvSpPr>
        <p:spPr>
          <a:xfrm>
            <a:off x="576416" y="5869162"/>
            <a:ext cx="1028648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dle    Apic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テキスト ボックス 34">
            <a:extLst>
              <a:ext uri="{FF2B5EF4-FFF2-40B4-BE49-F238E27FC236}">
                <a16:creationId xmlns:a16="http://schemas.microsoft.com/office/drawing/2014/main" id="{C187AF74-D0A1-3F45-A855-17B596106071}"/>
              </a:ext>
            </a:extLst>
          </p:cNvPr>
          <p:cNvSpPr txBox="1"/>
          <p:nvPr/>
        </p:nvSpPr>
        <p:spPr>
          <a:xfrm>
            <a:off x="2113640" y="5868973"/>
            <a:ext cx="1028648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dle    Apic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テキスト ボックス 34">
            <a:extLst>
              <a:ext uri="{FF2B5EF4-FFF2-40B4-BE49-F238E27FC236}">
                <a16:creationId xmlns:a16="http://schemas.microsoft.com/office/drawing/2014/main" id="{D788E829-A9E3-1D4A-A733-15A4CAFD20B7}"/>
              </a:ext>
            </a:extLst>
          </p:cNvPr>
          <p:cNvSpPr txBox="1"/>
          <p:nvPr/>
        </p:nvSpPr>
        <p:spPr>
          <a:xfrm>
            <a:off x="3802619" y="5874938"/>
            <a:ext cx="1028648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dle    Apic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テキスト ボックス 34">
            <a:extLst>
              <a:ext uri="{FF2B5EF4-FFF2-40B4-BE49-F238E27FC236}">
                <a16:creationId xmlns:a16="http://schemas.microsoft.com/office/drawing/2014/main" id="{D201730A-A8FA-A54B-9337-755F1B02C0C7}"/>
              </a:ext>
            </a:extLst>
          </p:cNvPr>
          <p:cNvSpPr txBox="1"/>
          <p:nvPr/>
        </p:nvSpPr>
        <p:spPr>
          <a:xfrm>
            <a:off x="5419792" y="5868972"/>
            <a:ext cx="1028648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dle    Apic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テキスト ボックス 34">
            <a:extLst>
              <a:ext uri="{FF2B5EF4-FFF2-40B4-BE49-F238E27FC236}">
                <a16:creationId xmlns:a16="http://schemas.microsoft.com/office/drawing/2014/main" id="{6E7B0C5F-4C1F-8541-BACF-40EE5512E80E}"/>
              </a:ext>
            </a:extLst>
          </p:cNvPr>
          <p:cNvSpPr txBox="1"/>
          <p:nvPr/>
        </p:nvSpPr>
        <p:spPr>
          <a:xfrm>
            <a:off x="547433" y="7783124"/>
            <a:ext cx="1028648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ddle    Apical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452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913</TotalTime>
  <Words>59</Words>
  <Application>Microsoft Office PowerPoint</Application>
  <PresentationFormat>A4 210 x 297 mm</PresentationFormat>
  <Paragraphs>4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Helvetica</vt:lpstr>
      <vt:lpstr>Times New Roman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in Neang</dc:creator>
  <cp:lastModifiedBy>三屋 史朗</cp:lastModifiedBy>
  <cp:revision>90</cp:revision>
  <cp:lastPrinted>2020-08-12T07:18:28Z</cp:lastPrinted>
  <dcterms:created xsi:type="dcterms:W3CDTF">2020-05-19T13:06:08Z</dcterms:created>
  <dcterms:modified xsi:type="dcterms:W3CDTF">2020-08-13T07:24:54Z</dcterms:modified>
</cp:coreProperties>
</file>